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1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dhuravasal Krishnan, Janani (jananimk)" userId="6969b20d-d298-4095-ade9-5a3c5ff7904a" providerId="ADAL" clId="{E82D250B-9DC9-49A3-92B3-1C8E085491B4}"/>
    <pc:docChg chg="undo custSel addSld delSld modSld">
      <pc:chgData name="Madhuravasal Krishnan, Janani (jananimk)" userId="6969b20d-d298-4095-ade9-5a3c5ff7904a" providerId="ADAL" clId="{E82D250B-9DC9-49A3-92B3-1C8E085491B4}" dt="2024-06-12T20:10:55.638" v="25" actId="20577"/>
      <pc:docMkLst>
        <pc:docMk/>
      </pc:docMkLst>
      <pc:sldChg chg="modSp add">
        <pc:chgData name="Madhuravasal Krishnan, Janani (jananimk)" userId="6969b20d-d298-4095-ade9-5a3c5ff7904a" providerId="ADAL" clId="{E82D250B-9DC9-49A3-92B3-1C8E085491B4}" dt="2024-06-12T20:10:55.638" v="25" actId="20577"/>
        <pc:sldMkLst>
          <pc:docMk/>
          <pc:sldMk cId="2275220239" sldId="257"/>
        </pc:sldMkLst>
        <pc:spChg chg="mod">
          <ac:chgData name="Madhuravasal Krishnan, Janani (jananimk)" userId="6969b20d-d298-4095-ade9-5a3c5ff7904a" providerId="ADAL" clId="{E82D250B-9DC9-49A3-92B3-1C8E085491B4}" dt="2024-06-12T20:10:55.638" v="25" actId="20577"/>
          <ac:spMkLst>
            <pc:docMk/>
            <pc:sldMk cId="2275220239" sldId="257"/>
            <ac:spMk id="11" creationId="{72022066-DCC0-2585-A0E7-F206908617F9}"/>
          </ac:spMkLst>
        </pc:spChg>
      </pc:sldChg>
    </pc:docChg>
  </pc:docChgLst>
  <pc:docChgLst>
    <pc:chgData name="Madhuravasal Krishnan, Janani (jananimk)" userId="6969b20d-d298-4095-ade9-5a3c5ff7904a" providerId="ADAL" clId="{47E87263-AECC-4C61-9A49-C0BB0DF8BB15}"/>
    <pc:docChg chg="modSld">
      <pc:chgData name="Madhuravasal Krishnan, Janani (jananimk)" userId="6969b20d-d298-4095-ade9-5a3c5ff7904a" providerId="ADAL" clId="{47E87263-AECC-4C61-9A49-C0BB0DF8BB15}" dt="2024-07-11T18:26:40.389" v="27" actId="1036"/>
      <pc:docMkLst>
        <pc:docMk/>
      </pc:docMkLst>
      <pc:sldChg chg="modSp">
        <pc:chgData name="Madhuravasal Krishnan, Janani (jananimk)" userId="6969b20d-d298-4095-ade9-5a3c5ff7904a" providerId="ADAL" clId="{47E87263-AECC-4C61-9A49-C0BB0DF8BB15}" dt="2024-07-11T18:26:40.389" v="27" actId="1036"/>
        <pc:sldMkLst>
          <pc:docMk/>
          <pc:sldMk cId="2275220239" sldId="257"/>
        </pc:sldMkLst>
        <pc:spChg chg="mod">
          <ac:chgData name="Madhuravasal Krishnan, Janani (jananimk)" userId="6969b20d-d298-4095-ade9-5a3c5ff7904a" providerId="ADAL" clId="{47E87263-AECC-4C61-9A49-C0BB0DF8BB15}" dt="2024-07-11T18:25:57.672" v="3" actId="123"/>
          <ac:spMkLst>
            <pc:docMk/>
            <pc:sldMk cId="2275220239" sldId="257"/>
            <ac:spMk id="11" creationId="{72022066-DCC0-2585-A0E7-F206908617F9}"/>
          </ac:spMkLst>
        </pc:spChg>
        <pc:graphicFrameChg chg="mod">
          <ac:chgData name="Madhuravasal Krishnan, Janani (jananimk)" userId="6969b20d-d298-4095-ade9-5a3c5ff7904a" providerId="ADAL" clId="{47E87263-AECC-4C61-9A49-C0BB0DF8BB15}" dt="2024-07-11T18:26:40.389" v="27" actId="1036"/>
          <ac:graphicFrameMkLst>
            <pc:docMk/>
            <pc:sldMk cId="2275220239" sldId="257"/>
            <ac:graphicFrameMk id="7" creationId="{44FACDE0-D059-4640-A4B8-46021B8E1F1F}"/>
          </ac:graphicFrameMkLst>
        </pc:graphicFrameChg>
        <pc:graphicFrameChg chg="mod">
          <ac:chgData name="Madhuravasal Krishnan, Janani (jananimk)" userId="6969b20d-d298-4095-ade9-5a3c5ff7904a" providerId="ADAL" clId="{47E87263-AECC-4C61-9A49-C0BB0DF8BB15}" dt="2024-07-11T18:26:30.536" v="15" actId="1036"/>
          <ac:graphicFrameMkLst>
            <pc:docMk/>
            <pc:sldMk cId="2275220239" sldId="257"/>
            <ac:graphicFrameMk id="12" creationId="{D179EF37-F084-4004-823E-75A4AD2C909B}"/>
          </ac:graphicFrameMkLst>
        </pc:graphicFrameChg>
      </pc:sldChg>
    </pc:docChg>
  </pc:docChgLst>
  <pc:docChgLst>
    <pc:chgData name="Madhuravasal Krishnan, Janani (jananimk)" userId="6969b20d-d298-4095-ade9-5a3c5ff7904a" providerId="ADAL" clId="{E7D4F65B-8325-4D5E-B005-F7525B30DB8A}"/>
    <pc:docChg chg="undo custSel modSld">
      <pc:chgData name="Madhuravasal Krishnan, Janani (jananimk)" userId="6969b20d-d298-4095-ade9-5a3c5ff7904a" providerId="ADAL" clId="{E7D4F65B-8325-4D5E-B005-F7525B30DB8A}" dt="2024-08-29T16:02:56.727" v="621"/>
      <pc:docMkLst>
        <pc:docMk/>
      </pc:docMkLst>
      <pc:sldChg chg="addSp delSp modSp">
        <pc:chgData name="Madhuravasal Krishnan, Janani (jananimk)" userId="6969b20d-d298-4095-ade9-5a3c5ff7904a" providerId="ADAL" clId="{E7D4F65B-8325-4D5E-B005-F7525B30DB8A}" dt="2024-08-29T16:02:56.727" v="621"/>
        <pc:sldMkLst>
          <pc:docMk/>
          <pc:sldMk cId="2275220239" sldId="257"/>
        </pc:sldMkLst>
        <pc:spChg chg="add">
          <ac:chgData name="Madhuravasal Krishnan, Janani (jananimk)" userId="6969b20d-d298-4095-ade9-5a3c5ff7904a" providerId="ADAL" clId="{E7D4F65B-8325-4D5E-B005-F7525B30DB8A}" dt="2024-08-29T15:55:43.290" v="459"/>
          <ac:spMkLst>
            <pc:docMk/>
            <pc:sldMk cId="2275220239" sldId="257"/>
            <ac:spMk id="4" creationId="{5CB7BA8C-EA45-43D2-BAD3-CB22E934E33B}"/>
          </ac:spMkLst>
        </pc:spChg>
        <pc:spChg chg="add">
          <ac:chgData name="Madhuravasal Krishnan, Janani (jananimk)" userId="6969b20d-d298-4095-ade9-5a3c5ff7904a" providerId="ADAL" clId="{E7D4F65B-8325-4D5E-B005-F7525B30DB8A}" dt="2024-08-29T15:55:43.290" v="459"/>
          <ac:spMkLst>
            <pc:docMk/>
            <pc:sldMk cId="2275220239" sldId="257"/>
            <ac:spMk id="5" creationId="{B4778D45-F687-4E02-BB52-BFADC467E174}"/>
          </ac:spMkLst>
        </pc:spChg>
        <pc:spChg chg="del">
          <ac:chgData name="Madhuravasal Krishnan, Janani (jananimk)" userId="6969b20d-d298-4095-ade9-5a3c5ff7904a" providerId="ADAL" clId="{E7D4F65B-8325-4D5E-B005-F7525B30DB8A}" dt="2024-08-28T15:54:41.905" v="0" actId="478"/>
          <ac:spMkLst>
            <pc:docMk/>
            <pc:sldMk cId="2275220239" sldId="257"/>
            <ac:spMk id="5" creationId="{D2A45B09-3869-452E-875E-78D2F0785494}"/>
          </ac:spMkLst>
        </pc:spChg>
        <pc:spChg chg="add mod">
          <ac:chgData name="Madhuravasal Krishnan, Janani (jananimk)" userId="6969b20d-d298-4095-ade9-5a3c5ff7904a" providerId="ADAL" clId="{E7D4F65B-8325-4D5E-B005-F7525B30DB8A}" dt="2024-08-28T16:07:16.263" v="451" actId="6549"/>
          <ac:spMkLst>
            <pc:docMk/>
            <pc:sldMk cId="2275220239" sldId="257"/>
            <ac:spMk id="8" creationId="{53449086-845F-45D1-B993-01C3A532FEF3}"/>
          </ac:spMkLst>
        </pc:spChg>
        <pc:spChg chg="del">
          <ac:chgData name="Madhuravasal Krishnan, Janani (jananimk)" userId="6969b20d-d298-4095-ade9-5a3c5ff7904a" providerId="ADAL" clId="{E7D4F65B-8325-4D5E-B005-F7525B30DB8A}" dt="2024-08-28T15:54:41.905" v="0" actId="478"/>
          <ac:spMkLst>
            <pc:docMk/>
            <pc:sldMk cId="2275220239" sldId="257"/>
            <ac:spMk id="11" creationId="{72022066-DCC0-2585-A0E7-F206908617F9}"/>
          </ac:spMkLst>
        </pc:spChg>
        <pc:grpChg chg="add del mod">
          <ac:chgData name="Madhuravasal Krishnan, Janani (jananimk)" userId="6969b20d-d298-4095-ade9-5a3c5ff7904a" providerId="ADAL" clId="{E7D4F65B-8325-4D5E-B005-F7525B30DB8A}" dt="2024-08-29T16:02:56.178" v="620" actId="478"/>
          <ac:grpSpMkLst>
            <pc:docMk/>
            <pc:sldMk cId="2275220239" sldId="257"/>
            <ac:grpSpMk id="3" creationId="{4A24EE4E-79B9-40BE-94C7-F292A0EEA8B4}"/>
          </ac:grpSpMkLst>
        </pc:grpChg>
        <pc:graphicFrameChg chg="del">
          <ac:chgData name="Madhuravasal Krishnan, Janani (jananimk)" userId="6969b20d-d298-4095-ade9-5a3c5ff7904a" providerId="ADAL" clId="{E7D4F65B-8325-4D5E-B005-F7525B30DB8A}" dt="2024-08-28T15:54:41.905" v="0" actId="478"/>
          <ac:graphicFrameMkLst>
            <pc:docMk/>
            <pc:sldMk cId="2275220239" sldId="257"/>
            <ac:graphicFrameMk id="7" creationId="{44FACDE0-D059-4640-A4B8-46021B8E1F1F}"/>
          </ac:graphicFrameMkLst>
        </pc:graphicFrameChg>
        <pc:graphicFrameChg chg="del">
          <ac:chgData name="Madhuravasal Krishnan, Janani (jananimk)" userId="6969b20d-d298-4095-ade9-5a3c5ff7904a" providerId="ADAL" clId="{E7D4F65B-8325-4D5E-B005-F7525B30DB8A}" dt="2024-08-28T15:54:41.905" v="0" actId="478"/>
          <ac:graphicFrameMkLst>
            <pc:docMk/>
            <pc:sldMk cId="2275220239" sldId="257"/>
            <ac:graphicFrameMk id="12" creationId="{D179EF37-F084-4004-823E-75A4AD2C909B}"/>
          </ac:graphicFrameMkLst>
        </pc:graphicFrameChg>
        <pc:picChg chg="add mod modCrop">
          <ac:chgData name="Madhuravasal Krishnan, Janani (jananimk)" userId="6969b20d-d298-4095-ade9-5a3c5ff7904a" providerId="ADAL" clId="{E7D4F65B-8325-4D5E-B005-F7525B30DB8A}" dt="2024-08-29T16:00:55.153" v="595" actId="164"/>
          <ac:picMkLst>
            <pc:docMk/>
            <pc:sldMk cId="2275220239" sldId="257"/>
            <ac:picMk id="2" creationId="{F12297CF-5DF1-46C5-8E06-66043991D67E}"/>
          </ac:picMkLst>
        </pc:picChg>
        <pc:picChg chg="add del mod modCrop">
          <ac:chgData name="Madhuravasal Krishnan, Janani (jananimk)" userId="6969b20d-d298-4095-ade9-5a3c5ff7904a" providerId="ADAL" clId="{E7D4F65B-8325-4D5E-B005-F7525B30DB8A}" dt="2024-08-29T15:57:42.481" v="538" actId="478"/>
          <ac:picMkLst>
            <pc:docMk/>
            <pc:sldMk cId="2275220239" sldId="257"/>
            <ac:picMk id="3" creationId="{502C29F1-A300-4BFA-9806-9C810817AF4B}"/>
          </ac:picMkLst>
        </pc:picChg>
        <pc:picChg chg="add del">
          <ac:chgData name="Madhuravasal Krishnan, Janani (jananimk)" userId="6969b20d-d298-4095-ade9-5a3c5ff7904a" providerId="ADAL" clId="{E7D4F65B-8325-4D5E-B005-F7525B30DB8A}" dt="2024-08-29T16:02:11.941" v="618"/>
          <ac:picMkLst>
            <pc:docMk/>
            <pc:sldMk cId="2275220239" sldId="257"/>
            <ac:picMk id="4" creationId="{20BEB4DE-D1C6-447E-85F2-61FB44FD8C0E}"/>
          </ac:picMkLst>
        </pc:picChg>
        <pc:picChg chg="add">
          <ac:chgData name="Madhuravasal Krishnan, Janani (jananimk)" userId="6969b20d-d298-4095-ade9-5a3c5ff7904a" providerId="ADAL" clId="{E7D4F65B-8325-4D5E-B005-F7525B30DB8A}" dt="2024-08-29T16:02:56.727" v="621"/>
          <ac:picMkLst>
            <pc:docMk/>
            <pc:sldMk cId="2275220239" sldId="257"/>
            <ac:picMk id="5" creationId="{B9AED973-EAF9-4727-859A-6996388FA844}"/>
          </ac:picMkLst>
        </pc:picChg>
        <pc:picChg chg="add del">
          <ac:chgData name="Madhuravasal Krishnan, Janani (jananimk)" userId="6969b20d-d298-4095-ade9-5a3c5ff7904a" providerId="ADAL" clId="{E7D4F65B-8325-4D5E-B005-F7525B30DB8A}" dt="2024-08-29T15:58:00.513" v="541"/>
          <ac:picMkLst>
            <pc:docMk/>
            <pc:sldMk cId="2275220239" sldId="257"/>
            <ac:picMk id="6" creationId="{678876FF-18E1-4C61-8EEC-105C31BBBB6F}"/>
          </ac:picMkLst>
        </pc:picChg>
        <pc:picChg chg="add del mod">
          <ac:chgData name="Madhuravasal Krishnan, Janani (jananimk)" userId="6969b20d-d298-4095-ade9-5a3c5ff7904a" providerId="ADAL" clId="{E7D4F65B-8325-4D5E-B005-F7525B30DB8A}" dt="2024-08-28T15:54:54.156" v="29" actId="478"/>
          <ac:picMkLst>
            <pc:docMk/>
            <pc:sldMk cId="2275220239" sldId="257"/>
            <ac:picMk id="6" creationId="{76E4E998-63AC-4EBA-9A5B-CDD929001B98}"/>
          </ac:picMkLst>
        </pc:picChg>
        <pc:picChg chg="add del mod modCrop">
          <ac:chgData name="Madhuravasal Krishnan, Janani (jananimk)" userId="6969b20d-d298-4095-ade9-5a3c5ff7904a" providerId="ADAL" clId="{E7D4F65B-8325-4D5E-B005-F7525B30DB8A}" dt="2024-08-29T15:57:43.601" v="539" actId="478"/>
          <ac:picMkLst>
            <pc:docMk/>
            <pc:sldMk cId="2275220239" sldId="257"/>
            <ac:picMk id="7" creationId="{CDA23324-3E4B-4D90-BB3E-D7B08D908DD1}"/>
          </ac:picMkLst>
        </pc:picChg>
        <pc:picChg chg="add mod">
          <ac:chgData name="Madhuravasal Krishnan, Janani (jananimk)" userId="6969b20d-d298-4095-ade9-5a3c5ff7904a" providerId="ADAL" clId="{E7D4F65B-8325-4D5E-B005-F7525B30DB8A}" dt="2024-08-29T16:00:55.153" v="595" actId="164"/>
          <ac:picMkLst>
            <pc:docMk/>
            <pc:sldMk cId="2275220239" sldId="257"/>
            <ac:picMk id="9" creationId="{1A721827-CE8D-447A-B745-DDDDB511FF01}"/>
          </ac:picMkLst>
        </pc:picChg>
        <pc:picChg chg="add mod">
          <ac:chgData name="Madhuravasal Krishnan, Janani (jananimk)" userId="6969b20d-d298-4095-ade9-5a3c5ff7904a" providerId="ADAL" clId="{E7D4F65B-8325-4D5E-B005-F7525B30DB8A}" dt="2024-08-29T16:00:55.153" v="595" actId="164"/>
          <ac:picMkLst>
            <pc:docMk/>
            <pc:sldMk cId="2275220239" sldId="257"/>
            <ac:picMk id="10" creationId="{BCF04DE6-60D9-48F6-8C13-53C3BB2C05E2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C6D11A9-143C-477D-BD87-5636CD8B72B0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2DDA09-50C8-4D60-A12A-30BC89EF8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2539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2DDA09-50C8-4D60-A12A-30BC89EF8FD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41363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A01786-B61B-46FB-B88B-2F376C302D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3501486-2457-4E5B-A5CE-FADC175FCB7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F46248-AE25-4EB7-ADDB-03D64EA7F9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68648D-EA7F-4005-BE15-074E93A9E8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844C96-A1C6-4C7E-805C-BDB80A2CD3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3188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B7BA09-3D50-4BEB-8C04-EED70C50D0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8D00B57-5F72-4464-9934-E400D54DFB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3E5058-27F6-4B7B-8F61-8D6F8304E5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20EA8D-CF48-4525-8250-185F5A69D4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7A2F2C-7651-429E-AD05-0C63BAD2CB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7190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AB3FFB6-8F3A-4DC3-9E62-2A3EC0EE55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544CCC-AFC1-48D1-B5A8-D08BF607E5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429F53-7B0F-4C99-9BED-65FB2BBE27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6DF0E2-6881-4BCA-9A4C-10F2F5CD72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2CF237-2BAB-412D-BC70-F60ACD165F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525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2555CF-5DB9-4F0A-A3C7-8B8CBE1008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30142F-CF63-49C8-8C81-326D1F19B1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021835-F1A7-4720-8977-F14B525C5D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6CD849-92A6-4E5A-9F58-E756895DAF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886A98-A517-46F3-BDBB-F99D4B763A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2598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73E253-4F79-4B62-9632-6CC25D8619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9BD847-2A18-4FC2-AD99-E60BA99501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E14F71-206E-4E47-BAC3-A9CC9794F8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231262-B240-4489-A41D-9A5164BE6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CF10E1-D2E6-41C3-B56A-49AAE7BE8C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1958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0DD20F-AA49-435C-9B48-6356CC165E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D6E457-1370-4CDC-BD05-77B66F4A1F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068835-BDED-4F5A-9C3D-0EFB654326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A0CCEF-1CA2-4F57-8347-02DBF7112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5779C0-515A-4379-B6A0-1E2B027C7C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67EFD2-2FF3-4BDC-823E-904493D68F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884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098C87-4474-4867-B2C2-38EB9A5688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1D3771-C594-4699-B7BC-FA771F3026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C94DB14-20EB-4D5A-BA9B-10BE4E53BB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C300145-8C51-43B0-AC21-0142C827C2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220356A-4E6E-4BC9-BA8A-4F0A2CD7DF4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C437640-10CC-4B01-8FB9-7EF0861477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61179F5-9265-4798-AA38-4577DBD46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C98E72A-6707-4390-9866-C554DB60B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61024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369D10-55D2-4695-AF94-C5C639F3C1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2667928-096E-4A89-AF56-FE1B908D0E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ABF7D1F-3B6A-47D9-924F-43DDD47857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DB13AD5-8F66-450F-8377-EFEB153250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634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21C4790-0DA5-4EEF-8ACB-E0424BC3E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6BA23EE-4447-4BAD-9EAA-3A746196FA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50A4DB4-5984-4028-9228-F6981389D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8701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D3D213-6776-42E8-99F5-49A65E8D88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E80680-AC4B-44D4-9B90-934E381BA66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E55866-73B2-4BA1-A1F1-7B286645B7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0F4FDB-1E4E-4FCF-9243-BF5432D999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66B38F-B3DA-48CB-8942-F11FA86B82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E93A1E-8DC9-4DE9-A0AB-4151C872B1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5769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C7558D-2D4C-495C-A205-B6550FBDC6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5C39AD5-F6F2-4029-B6F0-0B2930DE2A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9D15BDE-A24C-4B08-9110-BE30945C0A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F2DF27-BB56-461C-8D5F-5B8DC3B68A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F1A4-DF02-439A-9151-7ED592A30C9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CD5DC5-7ECC-4FC4-AF91-517E268B26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914205-F211-4009-B531-AB46146B57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219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F67C2C5-60D2-43E6-9256-D0A3E87E34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CAC488-6DDA-4A15-A627-DFA1150F44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EF4D44-61F7-42BC-BFB0-DF598140DC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CF1A4-DF02-439A-9151-7ED592A30C9F}" type="datetimeFigureOut">
              <a:rPr lang="en-US" smtClean="0"/>
              <a:t>8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4B2832-1511-43ED-B464-942D95E045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0F0D9B-9D65-45F5-8BB8-D6D2A65CF2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FBE1EC-67D4-417F-8B8C-771776073E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8433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53449086-845F-45D1-B993-01C3A532FEF3}"/>
              </a:ext>
            </a:extLst>
          </p:cNvPr>
          <p:cNvSpPr txBox="1"/>
          <p:nvPr/>
        </p:nvSpPr>
        <p:spPr>
          <a:xfrm>
            <a:off x="0" y="6583052"/>
            <a:ext cx="1219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Times New Roman" panose="02020603050405020304" pitchFamily="18" charset="0"/>
              </a:rPr>
              <a:t>Supplementary figure 8</a:t>
            </a:r>
            <a:r>
              <a:rPr lang="en-US" sz="1200" dirty="0">
                <a:latin typeface="Times New Roman" panose="02020603050405020304" pitchFamily="18" charset="0"/>
              </a:rPr>
              <a:t>: Dot plot of interferon stimulated genes associated with HIV in CD4</a:t>
            </a:r>
            <a:r>
              <a:rPr lang="en-US" sz="1200" baseline="30000" dirty="0">
                <a:latin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</a:rPr>
              <a:t> T lymphocytes infected with HIV </a:t>
            </a:r>
            <a:r>
              <a:rPr lang="en-US" sz="1200" baseline="-25000" dirty="0">
                <a:latin typeface="Times New Roman" panose="02020603050405020304" pitchFamily="18" charset="0"/>
              </a:rPr>
              <a:t>NL4-3</a:t>
            </a:r>
            <a:r>
              <a:rPr lang="en-US" sz="1200" dirty="0">
                <a:latin typeface="Times New Roman" panose="02020603050405020304" pitchFamily="18" charset="0"/>
              </a:rPr>
              <a:t> with and without fentanyl exposure.</a:t>
            </a:r>
            <a:endParaRPr lang="en-US" sz="12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9AED973-EAF9-4727-859A-6996388FA8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355624"/>
            <a:ext cx="12192000" cy="41467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52202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29</Words>
  <Application>Microsoft Office PowerPoint</Application>
  <PresentationFormat>Widescreen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huravasal Krishnan, Janani (jananimk)</dc:creator>
  <cp:lastModifiedBy>Madhuravasal Krishnan, Janani (jananimk)</cp:lastModifiedBy>
  <cp:revision>2</cp:revision>
  <dcterms:created xsi:type="dcterms:W3CDTF">2024-06-12T20:04:34Z</dcterms:created>
  <dcterms:modified xsi:type="dcterms:W3CDTF">2024-08-29T16:03:00Z</dcterms:modified>
</cp:coreProperties>
</file>